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9" r:id="rId2"/>
  </p:sldIdLst>
  <p:sldSz cx="6858000" cy="9906000" type="A4"/>
  <p:notesSz cx="6797675" cy="9926638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FEEC"/>
    <a:srgbClr val="663300"/>
    <a:srgbClr val="996633"/>
    <a:srgbClr val="F8C1B6"/>
    <a:srgbClr val="2FFFCD"/>
    <a:srgbClr val="FF47FF"/>
    <a:srgbClr val="F03218"/>
    <a:srgbClr val="FFCC00"/>
    <a:srgbClr val="096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3820" autoAdjust="0"/>
    <p:restoredTop sz="86407" autoAdjust="0"/>
  </p:normalViewPr>
  <p:slideViewPr>
    <p:cSldViewPr snapToGrid="0">
      <p:cViewPr varScale="1">
        <p:scale>
          <a:sx n="99" d="100"/>
          <a:sy n="99" d="100"/>
        </p:scale>
        <p:origin x="1956" y="10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13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8337092505494315E-2"/>
          <c:y val="2.6649355713196467E-2"/>
          <c:w val="0.8523632802959823"/>
          <c:h val="0.70399280600928671"/>
        </c:manualLayout>
      </c:layout>
      <c:barChart>
        <c:barDir val="col"/>
        <c:grouping val="clustered"/>
        <c:varyColors val="0"/>
        <c:ser>
          <c:idx val="1"/>
          <c:order val="1"/>
          <c:tx>
            <c:strRef>
              <c:f>'[SF1. thyroid MALT coverage and DNA quality_v1.xlsx]SF2'!$D$1</c:f>
              <c:strCache>
                <c:ptCount val="1"/>
                <c:pt idx="0">
                  <c:v>coverage %&gt;50 (%)</c:v>
                </c:pt>
              </c:strCache>
            </c:strRef>
          </c:tx>
          <c:spPr>
            <a:solidFill>
              <a:schemeClr val="accent1">
                <a:tint val="77000"/>
              </a:schemeClr>
            </a:solidFill>
            <a:ln>
              <a:noFill/>
            </a:ln>
            <a:effectLst/>
          </c:spPr>
          <c:invertIfNegative val="0"/>
          <c:cat>
            <c:strRef>
              <c:f>'[SF1. thyroid MALT coverage and DNA quality_v1.xlsx]SF2'!$B$2:$B$79</c:f>
              <c:strCache>
                <c:ptCount val="76"/>
                <c:pt idx="0">
                  <c:v>TM_1*</c:v>
                </c:pt>
                <c:pt idx="1">
                  <c:v>TM_2*</c:v>
                </c:pt>
                <c:pt idx="2">
                  <c:v>TM_3*</c:v>
                </c:pt>
                <c:pt idx="3">
                  <c:v>TM_8*</c:v>
                </c:pt>
                <c:pt idx="4">
                  <c:v>TM_9*</c:v>
                </c:pt>
                <c:pt idx="5">
                  <c:v>TM_10*</c:v>
                </c:pt>
                <c:pt idx="6">
                  <c:v>TM_11*</c:v>
                </c:pt>
                <c:pt idx="7">
                  <c:v>TM_13*</c:v>
                </c:pt>
                <c:pt idx="8">
                  <c:v>TM_15*</c:v>
                </c:pt>
                <c:pt idx="9">
                  <c:v>TM_19*</c:v>
                </c:pt>
                <c:pt idx="10">
                  <c:v>TM_20*</c:v>
                </c:pt>
                <c:pt idx="11">
                  <c:v>TM_22*</c:v>
                </c:pt>
                <c:pt idx="12">
                  <c:v>TM_23*</c:v>
                </c:pt>
                <c:pt idx="13">
                  <c:v>TM_25*</c:v>
                </c:pt>
                <c:pt idx="14">
                  <c:v>TM_27*</c:v>
                </c:pt>
                <c:pt idx="15">
                  <c:v>TM_32*</c:v>
                </c:pt>
                <c:pt idx="16">
                  <c:v>TM_34*</c:v>
                </c:pt>
                <c:pt idx="17">
                  <c:v>TM_35*</c:v>
                </c:pt>
                <c:pt idx="18">
                  <c:v>TM_37*</c:v>
                </c:pt>
                <c:pt idx="19">
                  <c:v>TM_38*</c:v>
                </c:pt>
                <c:pt idx="20">
                  <c:v>TM_39*</c:v>
                </c:pt>
                <c:pt idx="21">
                  <c:v>TM_41*</c:v>
                </c:pt>
                <c:pt idx="22">
                  <c:v>TM_48*</c:v>
                </c:pt>
                <c:pt idx="23">
                  <c:v>TM_54*</c:v>
                </c:pt>
                <c:pt idx="24">
                  <c:v>TM_76*</c:v>
                </c:pt>
                <c:pt idx="25">
                  <c:v>TM_57*</c:v>
                </c:pt>
                <c:pt idx="26">
                  <c:v>TM_58*</c:v>
                </c:pt>
                <c:pt idx="27">
                  <c:v>TM_63*</c:v>
                </c:pt>
                <c:pt idx="28">
                  <c:v>TM_74*</c:v>
                </c:pt>
                <c:pt idx="29">
                  <c:v>TM_4</c:v>
                </c:pt>
                <c:pt idx="30">
                  <c:v>TM_5</c:v>
                </c:pt>
                <c:pt idx="31">
                  <c:v>TM_6</c:v>
                </c:pt>
                <c:pt idx="32">
                  <c:v>TM_7</c:v>
                </c:pt>
                <c:pt idx="33">
                  <c:v>TM_12</c:v>
                </c:pt>
                <c:pt idx="34">
                  <c:v>TM_14</c:v>
                </c:pt>
                <c:pt idx="35">
                  <c:v>TM_17</c:v>
                </c:pt>
                <c:pt idx="36">
                  <c:v>TM_21</c:v>
                </c:pt>
                <c:pt idx="37">
                  <c:v>TM_24</c:v>
                </c:pt>
                <c:pt idx="38">
                  <c:v>TM_26</c:v>
                </c:pt>
                <c:pt idx="39">
                  <c:v>TM_28</c:v>
                </c:pt>
                <c:pt idx="40">
                  <c:v>TM_29</c:v>
                </c:pt>
                <c:pt idx="41">
                  <c:v>TM_30</c:v>
                </c:pt>
                <c:pt idx="42">
                  <c:v>TM_31</c:v>
                </c:pt>
                <c:pt idx="43">
                  <c:v>TM_33</c:v>
                </c:pt>
                <c:pt idx="44">
                  <c:v>TM_36</c:v>
                </c:pt>
                <c:pt idx="45">
                  <c:v>TM_75</c:v>
                </c:pt>
                <c:pt idx="46">
                  <c:v>TM_45</c:v>
                </c:pt>
                <c:pt idx="47">
                  <c:v>TM_46</c:v>
                </c:pt>
                <c:pt idx="48">
                  <c:v>TM_47</c:v>
                </c:pt>
                <c:pt idx="49">
                  <c:v>TM_49</c:v>
                </c:pt>
                <c:pt idx="50">
                  <c:v>TM_55</c:v>
                </c:pt>
                <c:pt idx="51">
                  <c:v>TM_67</c:v>
                </c:pt>
                <c:pt idx="52">
                  <c:v>TM_70</c:v>
                </c:pt>
                <c:pt idx="53">
                  <c:v>TM_18*</c:v>
                </c:pt>
                <c:pt idx="54">
                  <c:v>TM_16</c:v>
                </c:pt>
                <c:pt idx="55">
                  <c:v>TM_40</c:v>
                </c:pt>
                <c:pt idx="56">
                  <c:v>TM_42</c:v>
                </c:pt>
                <c:pt idx="57">
                  <c:v>TM_43</c:v>
                </c:pt>
                <c:pt idx="58">
                  <c:v>TM_44</c:v>
                </c:pt>
                <c:pt idx="59">
                  <c:v>TM_50</c:v>
                </c:pt>
                <c:pt idx="60">
                  <c:v>TM_51</c:v>
                </c:pt>
                <c:pt idx="61">
                  <c:v>TM_52</c:v>
                </c:pt>
                <c:pt idx="62">
                  <c:v>TM_53</c:v>
                </c:pt>
                <c:pt idx="63">
                  <c:v>TM_59</c:v>
                </c:pt>
                <c:pt idx="64">
                  <c:v>TM_60</c:v>
                </c:pt>
                <c:pt idx="65">
                  <c:v>TM_61</c:v>
                </c:pt>
                <c:pt idx="66">
                  <c:v>TM_62</c:v>
                </c:pt>
                <c:pt idx="67">
                  <c:v>TM_65</c:v>
                </c:pt>
                <c:pt idx="68">
                  <c:v>TM_66</c:v>
                </c:pt>
                <c:pt idx="69">
                  <c:v>TM_68</c:v>
                </c:pt>
                <c:pt idx="70">
                  <c:v>TM_69</c:v>
                </c:pt>
                <c:pt idx="71">
                  <c:v>TM_72</c:v>
                </c:pt>
                <c:pt idx="72">
                  <c:v>TM_73</c:v>
                </c:pt>
                <c:pt idx="73">
                  <c:v>TM_56</c:v>
                </c:pt>
                <c:pt idx="74">
                  <c:v>TM_64</c:v>
                </c:pt>
                <c:pt idx="75">
                  <c:v>TM_71</c:v>
                </c:pt>
              </c:strCache>
            </c:strRef>
          </c:cat>
          <c:val>
            <c:numRef>
              <c:f>'[SF1. thyroid MALT coverage and DNA quality_v1.xlsx]SF2'!$D$2:$D$79</c:f>
              <c:numCache>
                <c:formatCode>0%</c:formatCode>
                <c:ptCount val="78"/>
                <c:pt idx="0">
                  <c:v>0.86699999999999999</c:v>
                </c:pt>
                <c:pt idx="1">
                  <c:v>0.80925000000000002</c:v>
                </c:pt>
                <c:pt idx="2">
                  <c:v>0.86620000000000008</c:v>
                </c:pt>
                <c:pt idx="3">
                  <c:v>0.90784999999999993</c:v>
                </c:pt>
                <c:pt idx="4">
                  <c:v>0.88969999999999994</c:v>
                </c:pt>
                <c:pt idx="5">
                  <c:v>0.88174999999999992</c:v>
                </c:pt>
                <c:pt idx="6">
                  <c:v>0.80469999999999997</c:v>
                </c:pt>
                <c:pt idx="7">
                  <c:v>0.79965000000000008</c:v>
                </c:pt>
                <c:pt idx="8">
                  <c:v>0.90284999999999993</c:v>
                </c:pt>
                <c:pt idx="9">
                  <c:v>0.90215000000000001</c:v>
                </c:pt>
                <c:pt idx="10">
                  <c:v>0.8992</c:v>
                </c:pt>
                <c:pt idx="11">
                  <c:v>0.90859999999999996</c:v>
                </c:pt>
                <c:pt idx="12">
                  <c:v>0.76664999999999994</c:v>
                </c:pt>
                <c:pt idx="13">
                  <c:v>0.80909999999999993</c:v>
                </c:pt>
                <c:pt idx="14">
                  <c:v>0.90890000000000004</c:v>
                </c:pt>
                <c:pt idx="15">
                  <c:v>0.92390000000000005</c:v>
                </c:pt>
                <c:pt idx="16">
                  <c:v>0.90474999999999994</c:v>
                </c:pt>
                <c:pt idx="17">
                  <c:v>0.8931</c:v>
                </c:pt>
                <c:pt idx="18">
                  <c:v>0.89950000000000008</c:v>
                </c:pt>
                <c:pt idx="19">
                  <c:v>0.95194999999999996</c:v>
                </c:pt>
                <c:pt idx="20">
                  <c:v>0.87724999999999997</c:v>
                </c:pt>
                <c:pt idx="21">
                  <c:v>0.93194999999999995</c:v>
                </c:pt>
                <c:pt idx="22">
                  <c:v>0.88919999999999999</c:v>
                </c:pt>
                <c:pt idx="23">
                  <c:v>0.96245000000000003</c:v>
                </c:pt>
                <c:pt idx="24">
                  <c:v>0.93319999999999992</c:v>
                </c:pt>
                <c:pt idx="25">
                  <c:v>0.88944999999999996</c:v>
                </c:pt>
                <c:pt idx="26">
                  <c:v>0.97240000000000004</c:v>
                </c:pt>
                <c:pt idx="27">
                  <c:v>0.8841</c:v>
                </c:pt>
                <c:pt idx="28">
                  <c:v>0.83085000000000009</c:v>
                </c:pt>
                <c:pt idx="29">
                  <c:v>0.94739999999999991</c:v>
                </c:pt>
                <c:pt idx="30">
                  <c:v>0.92330000000000001</c:v>
                </c:pt>
                <c:pt idx="31">
                  <c:v>0.88390000000000002</c:v>
                </c:pt>
                <c:pt idx="32">
                  <c:v>0.86870000000000003</c:v>
                </c:pt>
                <c:pt idx="33">
                  <c:v>0.94370000000000009</c:v>
                </c:pt>
                <c:pt idx="34">
                  <c:v>0.92799999999999994</c:v>
                </c:pt>
                <c:pt idx="35">
                  <c:v>0.87439999999999996</c:v>
                </c:pt>
                <c:pt idx="36">
                  <c:v>0.91579999999999995</c:v>
                </c:pt>
                <c:pt idx="37">
                  <c:v>0.89819999999999989</c:v>
                </c:pt>
                <c:pt idx="38">
                  <c:v>0.94830000000000003</c:v>
                </c:pt>
                <c:pt idx="39">
                  <c:v>0.96959999999999991</c:v>
                </c:pt>
                <c:pt idx="40">
                  <c:v>0.95290000000000008</c:v>
                </c:pt>
                <c:pt idx="41">
                  <c:v>0.97629999999999995</c:v>
                </c:pt>
                <c:pt idx="42">
                  <c:v>0.95979999999999999</c:v>
                </c:pt>
                <c:pt idx="43">
                  <c:v>0.95900000000000007</c:v>
                </c:pt>
                <c:pt idx="44">
                  <c:v>0.94499999999999995</c:v>
                </c:pt>
                <c:pt idx="45">
                  <c:v>0.97629999999999995</c:v>
                </c:pt>
                <c:pt idx="46">
                  <c:v>0.9668000000000001</c:v>
                </c:pt>
                <c:pt idx="47">
                  <c:v>0.93420000000000003</c:v>
                </c:pt>
                <c:pt idx="48">
                  <c:v>0.93319999999999992</c:v>
                </c:pt>
                <c:pt idx="49">
                  <c:v>0.95209999999999995</c:v>
                </c:pt>
                <c:pt idx="50">
                  <c:v>0.98640000000000005</c:v>
                </c:pt>
                <c:pt idx="51">
                  <c:v>0.98260000000000003</c:v>
                </c:pt>
                <c:pt idx="52">
                  <c:v>0.97409999999999997</c:v>
                </c:pt>
                <c:pt idx="53">
                  <c:v>0.94810000000000005</c:v>
                </c:pt>
                <c:pt idx="54">
                  <c:v>0.98480000000000001</c:v>
                </c:pt>
                <c:pt idx="55">
                  <c:v>0.95299999999999996</c:v>
                </c:pt>
                <c:pt idx="56">
                  <c:v>0.9647</c:v>
                </c:pt>
                <c:pt idx="57">
                  <c:v>0.96620000000000006</c:v>
                </c:pt>
                <c:pt idx="58">
                  <c:v>0.97140000000000004</c:v>
                </c:pt>
                <c:pt idx="59">
                  <c:v>0.96439999999999992</c:v>
                </c:pt>
                <c:pt idx="60">
                  <c:v>0.98230000000000006</c:v>
                </c:pt>
                <c:pt idx="61">
                  <c:v>0.98860000000000003</c:v>
                </c:pt>
                <c:pt idx="62">
                  <c:v>0.99209999999999998</c:v>
                </c:pt>
                <c:pt idx="63">
                  <c:v>0.96810000000000007</c:v>
                </c:pt>
                <c:pt idx="64">
                  <c:v>0.98499999999999999</c:v>
                </c:pt>
                <c:pt idx="65">
                  <c:v>0.98560000000000003</c:v>
                </c:pt>
                <c:pt idx="66">
                  <c:v>0.98069999999999991</c:v>
                </c:pt>
                <c:pt idx="67">
                  <c:v>0.98019999999999996</c:v>
                </c:pt>
                <c:pt idx="68">
                  <c:v>0.9819</c:v>
                </c:pt>
                <c:pt idx="69">
                  <c:v>0.98269999999999991</c:v>
                </c:pt>
                <c:pt idx="70">
                  <c:v>0.96409999999999996</c:v>
                </c:pt>
                <c:pt idx="71">
                  <c:v>0.98319999999999996</c:v>
                </c:pt>
                <c:pt idx="72">
                  <c:v>0.91989999999999994</c:v>
                </c:pt>
                <c:pt idx="73">
                  <c:v>0.98790000000000011</c:v>
                </c:pt>
                <c:pt idx="74">
                  <c:v>0.98970000000000002</c:v>
                </c:pt>
                <c:pt idx="75">
                  <c:v>0.9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2F-45AE-A53C-00165D3311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95606784"/>
        <c:axId val="195604480"/>
      </c:barChart>
      <c:lineChart>
        <c:grouping val="standard"/>
        <c:varyColors val="0"/>
        <c:ser>
          <c:idx val="0"/>
          <c:order val="0"/>
          <c:tx>
            <c:strRef>
              <c:f>'[SF1. thyroid MALT coverage and DNA quality_v1.xlsx]SF2'!$C$1</c:f>
              <c:strCache>
                <c:ptCount val="1"/>
                <c:pt idx="0">
                  <c:v>average reads</c:v>
                </c:pt>
              </c:strCache>
            </c:strRef>
          </c:tx>
          <c:spPr>
            <a:ln w="1270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strRef>
              <c:f>'[SF1. thyroid MALT coverage and DNA quality_v1.xlsx]SF2'!$B$2:$B$79</c:f>
              <c:strCache>
                <c:ptCount val="76"/>
                <c:pt idx="0">
                  <c:v>TM_1*</c:v>
                </c:pt>
                <c:pt idx="1">
                  <c:v>TM_2*</c:v>
                </c:pt>
                <c:pt idx="2">
                  <c:v>TM_3*</c:v>
                </c:pt>
                <c:pt idx="3">
                  <c:v>TM_8*</c:v>
                </c:pt>
                <c:pt idx="4">
                  <c:v>TM_9*</c:v>
                </c:pt>
                <c:pt idx="5">
                  <c:v>TM_10*</c:v>
                </c:pt>
                <c:pt idx="6">
                  <c:v>TM_11*</c:v>
                </c:pt>
                <c:pt idx="7">
                  <c:v>TM_13*</c:v>
                </c:pt>
                <c:pt idx="8">
                  <c:v>TM_15*</c:v>
                </c:pt>
                <c:pt idx="9">
                  <c:v>TM_19*</c:v>
                </c:pt>
                <c:pt idx="10">
                  <c:v>TM_20*</c:v>
                </c:pt>
                <c:pt idx="11">
                  <c:v>TM_22*</c:v>
                </c:pt>
                <c:pt idx="12">
                  <c:v>TM_23*</c:v>
                </c:pt>
                <c:pt idx="13">
                  <c:v>TM_25*</c:v>
                </c:pt>
                <c:pt idx="14">
                  <c:v>TM_27*</c:v>
                </c:pt>
                <c:pt idx="15">
                  <c:v>TM_32*</c:v>
                </c:pt>
                <c:pt idx="16">
                  <c:v>TM_34*</c:v>
                </c:pt>
                <c:pt idx="17">
                  <c:v>TM_35*</c:v>
                </c:pt>
                <c:pt idx="18">
                  <c:v>TM_37*</c:v>
                </c:pt>
                <c:pt idx="19">
                  <c:v>TM_38*</c:v>
                </c:pt>
                <c:pt idx="20">
                  <c:v>TM_39*</c:v>
                </c:pt>
                <c:pt idx="21">
                  <c:v>TM_41*</c:v>
                </c:pt>
                <c:pt idx="22">
                  <c:v>TM_48*</c:v>
                </c:pt>
                <c:pt idx="23">
                  <c:v>TM_54*</c:v>
                </c:pt>
                <c:pt idx="24">
                  <c:v>TM_76*</c:v>
                </c:pt>
                <c:pt idx="25">
                  <c:v>TM_57*</c:v>
                </c:pt>
                <c:pt idx="26">
                  <c:v>TM_58*</c:v>
                </c:pt>
                <c:pt idx="27">
                  <c:v>TM_63*</c:v>
                </c:pt>
                <c:pt idx="28">
                  <c:v>TM_74*</c:v>
                </c:pt>
                <c:pt idx="29">
                  <c:v>TM_4</c:v>
                </c:pt>
                <c:pt idx="30">
                  <c:v>TM_5</c:v>
                </c:pt>
                <c:pt idx="31">
                  <c:v>TM_6</c:v>
                </c:pt>
                <c:pt idx="32">
                  <c:v>TM_7</c:v>
                </c:pt>
                <c:pt idx="33">
                  <c:v>TM_12</c:v>
                </c:pt>
                <c:pt idx="34">
                  <c:v>TM_14</c:v>
                </c:pt>
                <c:pt idx="35">
                  <c:v>TM_17</c:v>
                </c:pt>
                <c:pt idx="36">
                  <c:v>TM_21</c:v>
                </c:pt>
                <c:pt idx="37">
                  <c:v>TM_24</c:v>
                </c:pt>
                <c:pt idx="38">
                  <c:v>TM_26</c:v>
                </c:pt>
                <c:pt idx="39">
                  <c:v>TM_28</c:v>
                </c:pt>
                <c:pt idx="40">
                  <c:v>TM_29</c:v>
                </c:pt>
                <c:pt idx="41">
                  <c:v>TM_30</c:v>
                </c:pt>
                <c:pt idx="42">
                  <c:v>TM_31</c:v>
                </c:pt>
                <c:pt idx="43">
                  <c:v>TM_33</c:v>
                </c:pt>
                <c:pt idx="44">
                  <c:v>TM_36</c:v>
                </c:pt>
                <c:pt idx="45">
                  <c:v>TM_75</c:v>
                </c:pt>
                <c:pt idx="46">
                  <c:v>TM_45</c:v>
                </c:pt>
                <c:pt idx="47">
                  <c:v>TM_46</c:v>
                </c:pt>
                <c:pt idx="48">
                  <c:v>TM_47</c:v>
                </c:pt>
                <c:pt idx="49">
                  <c:v>TM_49</c:v>
                </c:pt>
                <c:pt idx="50">
                  <c:v>TM_55</c:v>
                </c:pt>
                <c:pt idx="51">
                  <c:v>TM_67</c:v>
                </c:pt>
                <c:pt idx="52">
                  <c:v>TM_70</c:v>
                </c:pt>
                <c:pt idx="53">
                  <c:v>TM_18*</c:v>
                </c:pt>
                <c:pt idx="54">
                  <c:v>TM_16</c:v>
                </c:pt>
                <c:pt idx="55">
                  <c:v>TM_40</c:v>
                </c:pt>
                <c:pt idx="56">
                  <c:v>TM_42</c:v>
                </c:pt>
                <c:pt idx="57">
                  <c:v>TM_43</c:v>
                </c:pt>
                <c:pt idx="58">
                  <c:v>TM_44</c:v>
                </c:pt>
                <c:pt idx="59">
                  <c:v>TM_50</c:v>
                </c:pt>
                <c:pt idx="60">
                  <c:v>TM_51</c:v>
                </c:pt>
                <c:pt idx="61">
                  <c:v>TM_52</c:v>
                </c:pt>
                <c:pt idx="62">
                  <c:v>TM_53</c:v>
                </c:pt>
                <c:pt idx="63">
                  <c:v>TM_59</c:v>
                </c:pt>
                <c:pt idx="64">
                  <c:v>TM_60</c:v>
                </c:pt>
                <c:pt idx="65">
                  <c:v>TM_61</c:v>
                </c:pt>
                <c:pt idx="66">
                  <c:v>TM_62</c:v>
                </c:pt>
                <c:pt idx="67">
                  <c:v>TM_65</c:v>
                </c:pt>
                <c:pt idx="68">
                  <c:v>TM_66</c:v>
                </c:pt>
                <c:pt idx="69">
                  <c:v>TM_68</c:v>
                </c:pt>
                <c:pt idx="70">
                  <c:v>TM_69</c:v>
                </c:pt>
                <c:pt idx="71">
                  <c:v>TM_72</c:v>
                </c:pt>
                <c:pt idx="72">
                  <c:v>TM_73</c:v>
                </c:pt>
                <c:pt idx="73">
                  <c:v>TM_56</c:v>
                </c:pt>
                <c:pt idx="74">
                  <c:v>TM_64</c:v>
                </c:pt>
                <c:pt idx="75">
                  <c:v>TM_71</c:v>
                </c:pt>
              </c:strCache>
            </c:strRef>
          </c:cat>
          <c:val>
            <c:numRef>
              <c:f>'[SF1. thyroid MALT coverage and DNA quality_v1.xlsx]SF2'!$C$2:$C$79</c:f>
              <c:numCache>
                <c:formatCode>General</c:formatCode>
                <c:ptCount val="78"/>
                <c:pt idx="0">
                  <c:v>712.4</c:v>
                </c:pt>
                <c:pt idx="1">
                  <c:v>478.27</c:v>
                </c:pt>
                <c:pt idx="2">
                  <c:v>550.53</c:v>
                </c:pt>
                <c:pt idx="3">
                  <c:v>972.43000000000006</c:v>
                </c:pt>
                <c:pt idx="4">
                  <c:v>670.84500000000003</c:v>
                </c:pt>
                <c:pt idx="5">
                  <c:v>642.57000000000005</c:v>
                </c:pt>
                <c:pt idx="6">
                  <c:v>474.46500000000003</c:v>
                </c:pt>
                <c:pt idx="7">
                  <c:v>351.88499999999999</c:v>
                </c:pt>
                <c:pt idx="8">
                  <c:v>584.04999999999995</c:v>
                </c:pt>
                <c:pt idx="9">
                  <c:v>1076.54</c:v>
                </c:pt>
                <c:pt idx="10">
                  <c:v>540.79500000000007</c:v>
                </c:pt>
                <c:pt idx="11">
                  <c:v>944.80500000000006</c:v>
                </c:pt>
                <c:pt idx="12">
                  <c:v>343.46999999999997</c:v>
                </c:pt>
                <c:pt idx="13">
                  <c:v>459.19</c:v>
                </c:pt>
                <c:pt idx="14">
                  <c:v>675.23</c:v>
                </c:pt>
                <c:pt idx="15">
                  <c:v>668.07999999999993</c:v>
                </c:pt>
                <c:pt idx="16">
                  <c:v>599.36</c:v>
                </c:pt>
                <c:pt idx="17">
                  <c:v>741.11500000000001</c:v>
                </c:pt>
                <c:pt idx="18">
                  <c:v>594.75</c:v>
                </c:pt>
                <c:pt idx="19">
                  <c:v>1131.51</c:v>
                </c:pt>
                <c:pt idx="20">
                  <c:v>675.55499999999995</c:v>
                </c:pt>
                <c:pt idx="21">
                  <c:v>524.20000000000005</c:v>
                </c:pt>
                <c:pt idx="22">
                  <c:v>609.46</c:v>
                </c:pt>
                <c:pt idx="23">
                  <c:v>640.875</c:v>
                </c:pt>
                <c:pt idx="24">
                  <c:v>697.52</c:v>
                </c:pt>
                <c:pt idx="25">
                  <c:v>560.03</c:v>
                </c:pt>
                <c:pt idx="26">
                  <c:v>875.21</c:v>
                </c:pt>
                <c:pt idx="27">
                  <c:v>456.14</c:v>
                </c:pt>
                <c:pt idx="28">
                  <c:v>361.745</c:v>
                </c:pt>
                <c:pt idx="29">
                  <c:v>1526.88</c:v>
                </c:pt>
                <c:pt idx="30">
                  <c:v>738.12</c:v>
                </c:pt>
                <c:pt idx="31">
                  <c:v>567.36</c:v>
                </c:pt>
                <c:pt idx="32">
                  <c:v>589.73</c:v>
                </c:pt>
                <c:pt idx="33">
                  <c:v>1150.67</c:v>
                </c:pt>
                <c:pt idx="34">
                  <c:v>884.93</c:v>
                </c:pt>
                <c:pt idx="35">
                  <c:v>576.97</c:v>
                </c:pt>
                <c:pt idx="36">
                  <c:v>572.76</c:v>
                </c:pt>
                <c:pt idx="37">
                  <c:v>688.09</c:v>
                </c:pt>
                <c:pt idx="38">
                  <c:v>1003.72</c:v>
                </c:pt>
                <c:pt idx="39">
                  <c:v>1529.55</c:v>
                </c:pt>
                <c:pt idx="40">
                  <c:v>1131.03</c:v>
                </c:pt>
                <c:pt idx="41">
                  <c:v>1514.93</c:v>
                </c:pt>
                <c:pt idx="42">
                  <c:v>1123.55</c:v>
                </c:pt>
                <c:pt idx="43">
                  <c:v>1261.6099999999999</c:v>
                </c:pt>
                <c:pt idx="44">
                  <c:v>1306.21</c:v>
                </c:pt>
                <c:pt idx="45">
                  <c:v>2131.6999999999998</c:v>
                </c:pt>
                <c:pt idx="46">
                  <c:v>1085.8900000000001</c:v>
                </c:pt>
                <c:pt idx="47">
                  <c:v>755.03</c:v>
                </c:pt>
                <c:pt idx="48">
                  <c:v>752.48</c:v>
                </c:pt>
                <c:pt idx="49">
                  <c:v>1293.4000000000001</c:v>
                </c:pt>
                <c:pt idx="50">
                  <c:v>2427.5</c:v>
                </c:pt>
                <c:pt idx="51">
                  <c:v>963.78</c:v>
                </c:pt>
                <c:pt idx="52">
                  <c:v>1383.8</c:v>
                </c:pt>
                <c:pt idx="53">
                  <c:v>910.94</c:v>
                </c:pt>
                <c:pt idx="54">
                  <c:v>2220.59</c:v>
                </c:pt>
                <c:pt idx="55">
                  <c:v>561.9</c:v>
                </c:pt>
                <c:pt idx="56">
                  <c:v>1054.68</c:v>
                </c:pt>
                <c:pt idx="57">
                  <c:v>1000.79</c:v>
                </c:pt>
                <c:pt idx="58">
                  <c:v>613.32000000000005</c:v>
                </c:pt>
                <c:pt idx="59">
                  <c:v>955.93</c:v>
                </c:pt>
                <c:pt idx="60">
                  <c:v>1069.0899999999999</c:v>
                </c:pt>
                <c:pt idx="61">
                  <c:v>1528.3</c:v>
                </c:pt>
                <c:pt idx="62">
                  <c:v>1725.79</c:v>
                </c:pt>
                <c:pt idx="63">
                  <c:v>941.69</c:v>
                </c:pt>
                <c:pt idx="64">
                  <c:v>1307.96</c:v>
                </c:pt>
                <c:pt idx="65">
                  <c:v>1316.62</c:v>
                </c:pt>
                <c:pt idx="66">
                  <c:v>945.53</c:v>
                </c:pt>
                <c:pt idx="67">
                  <c:v>1109.75</c:v>
                </c:pt>
                <c:pt idx="68">
                  <c:v>763.95</c:v>
                </c:pt>
                <c:pt idx="69">
                  <c:v>1027.27</c:v>
                </c:pt>
                <c:pt idx="70">
                  <c:v>901.13</c:v>
                </c:pt>
                <c:pt idx="71">
                  <c:v>1105.48</c:v>
                </c:pt>
                <c:pt idx="72">
                  <c:v>956.84</c:v>
                </c:pt>
                <c:pt idx="73">
                  <c:v>1175.04</c:v>
                </c:pt>
                <c:pt idx="74">
                  <c:v>1524.58</c:v>
                </c:pt>
                <c:pt idx="75">
                  <c:v>521.820000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22F-45AE-A53C-00165D3311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5008384"/>
        <c:axId val="195134592"/>
      </c:lineChart>
      <c:catAx>
        <c:axId val="195008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134592"/>
        <c:crosses val="autoZero"/>
        <c:auto val="1"/>
        <c:lblAlgn val="r"/>
        <c:lblOffset val="100"/>
        <c:noMultiLvlLbl val="0"/>
      </c:catAx>
      <c:valAx>
        <c:axId val="195134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/>
                  <a:t>Average read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008384"/>
        <c:crosses val="autoZero"/>
        <c:crossBetween val="between"/>
      </c:valAx>
      <c:valAx>
        <c:axId val="195604480"/>
        <c:scaling>
          <c:orientation val="minMax"/>
          <c:max val="1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 dirty="0" smtClean="0"/>
                  <a:t>Coverage</a:t>
                </a:r>
                <a:endParaRPr lang="en-US" sz="800" dirty="0"/>
              </a:p>
            </c:rich>
          </c:tx>
          <c:layout>
            <c:manualLayout>
              <c:xMode val="edge"/>
              <c:yMode val="edge"/>
              <c:x val="0.9608421324575509"/>
              <c:y val="0.3150581110852093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%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606784"/>
        <c:crosses val="max"/>
        <c:crossBetween val="between"/>
      </c:valAx>
      <c:catAx>
        <c:axId val="19560678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9560448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275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275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665EB616-CABF-4B7C-8565-3F13A2DBAE3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098549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3B58F2DE-17C5-4142-9F39-686B0848F31E}" type="datetimeFigureOut">
              <a:rPr lang="en-US"/>
              <a:pPr>
                <a:defRPr/>
              </a:pPr>
              <a:t>5/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04DFB875-2F53-4D6C-ADAB-812F19EB2EE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41754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9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3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7B3581-3040-4C47-ADF3-F7D4BDF131E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997098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717908-283F-4A2E-8FCF-7BC83614E92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835667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31" y="881063"/>
            <a:ext cx="1457325" cy="7924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5" y="881063"/>
            <a:ext cx="4219575" cy="7924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B84506-8937-496E-A9A5-506A604EF8F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592984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F88204-B65D-423C-82DF-4A8B8B464684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52936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8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8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8640E2-38E6-4B95-8168-088FE1B739E8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615939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DE9D79-45D0-4CF4-9705-888B56937B2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673268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6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9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9" y="3141666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736B4A-D98C-4FDE-82E5-666406FC6D72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334067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D88AC4-24D4-4E5E-9378-7ED6E2E80DB9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330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83B130-67A1-42C9-9B68-17CCECACC0B3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6615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3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4"/>
            <a:ext cx="2255838" cy="67754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2EAF75-1BEF-4565-B096-D8E8C0F6EE3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18544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49"/>
            <a:ext cx="4114800" cy="11620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3C5CCA-D13F-480E-AAE9-F766CFFA9F86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20478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ext styles</a:t>
            </a:r>
          </a:p>
          <a:p>
            <a:pPr lvl="1"/>
            <a:r>
              <a:rPr lang="en-GB" altLang="zh-CN" smtClean="0"/>
              <a:t>Second level</a:t>
            </a:r>
          </a:p>
          <a:p>
            <a:pPr lvl="2"/>
            <a:r>
              <a:rPr lang="en-GB" altLang="zh-CN" smtClean="0"/>
              <a:t>Third level</a:t>
            </a:r>
          </a:p>
          <a:p>
            <a:pPr lvl="3"/>
            <a:r>
              <a:rPr lang="en-GB" altLang="zh-CN" smtClean="0"/>
              <a:t>Fourth level</a:t>
            </a:r>
          </a:p>
          <a:p>
            <a:pPr lvl="4"/>
            <a:r>
              <a:rPr lang="en-GB" altLang="zh-CN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fld id="{CFB04EDC-854A-47E1-A7BC-53B84277158A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F3FA0CB-420D-4A34-B4B9-DB8DF86B70AB}"/>
              </a:ext>
            </a:extLst>
          </p:cNvPr>
          <p:cNvSpPr txBox="1"/>
          <p:nvPr/>
        </p:nvSpPr>
        <p:spPr>
          <a:xfrm>
            <a:off x="577381" y="4609345"/>
            <a:ext cx="570323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2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</a:t>
            </a:r>
            <a:r>
              <a:rPr lang="en-GB" altLang="zh-CN" sz="12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GB" altLang="zh-CN" sz="1200" b="1" dirty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Performance data of 93-gene panel sequencing in thyroid MALT lymphoma</a:t>
            </a:r>
            <a:r>
              <a:rPr lang="en-GB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.  Average depth read and sequence coverage with reads &gt;50 are shown.  DNA quality was assessed by a standardised quality control PCR, and 29 samples with suboptimal coverage and/or variants of uncertain (potential false positive) are investigated by the panel sequencing twice.    </a:t>
            </a:r>
          </a:p>
          <a:p>
            <a:endParaRPr lang="en-GB" sz="12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GB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470A1A4-9520-4A80-AAED-8126076F9439}"/>
              </a:ext>
            </a:extLst>
          </p:cNvPr>
          <p:cNvGrpSpPr/>
          <p:nvPr/>
        </p:nvGrpSpPr>
        <p:grpSpPr>
          <a:xfrm>
            <a:off x="256525" y="684887"/>
            <a:ext cx="6357951" cy="3809256"/>
            <a:chOff x="256525" y="322891"/>
            <a:chExt cx="6357951" cy="3809256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FBF4E395-F94B-44A6-AF77-82E7CE61053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4713390"/>
                </p:ext>
              </p:extLst>
            </p:nvPr>
          </p:nvGraphicFramePr>
          <p:xfrm>
            <a:off x="452215" y="322891"/>
            <a:ext cx="6162261" cy="38092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28AB2F5-47C8-4F73-9AF7-D654650A43AF}"/>
                </a:ext>
              </a:extLst>
            </p:cNvPr>
            <p:cNvGrpSpPr/>
            <p:nvPr/>
          </p:nvGrpSpPr>
          <p:grpSpPr>
            <a:xfrm>
              <a:off x="256525" y="3317302"/>
              <a:ext cx="5888942" cy="321578"/>
              <a:chOff x="256525" y="3317302"/>
              <a:chExt cx="5888942" cy="321578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8A59F111-493A-40AC-B030-193A0D5356E9}"/>
                  </a:ext>
                </a:extLst>
              </p:cNvPr>
              <p:cNvGrpSpPr/>
              <p:nvPr/>
            </p:nvGrpSpPr>
            <p:grpSpPr>
              <a:xfrm>
                <a:off x="898721" y="3372782"/>
                <a:ext cx="5082979" cy="91648"/>
                <a:chOff x="898721" y="3023027"/>
                <a:chExt cx="5082979" cy="91648"/>
              </a:xfrm>
            </p:grpSpPr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id="{4F980C13-8F83-4A5F-A773-5CE5F363C2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8721" y="3070256"/>
                  <a:ext cx="508297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0C53B772-1D39-45BB-AAC3-66CDFFF2C27D}"/>
                    </a:ext>
                  </a:extLst>
                </p:cNvPr>
                <p:cNvCxnSpPr/>
                <p:nvPr/>
              </p:nvCxnSpPr>
              <p:spPr>
                <a:xfrm>
                  <a:off x="901700" y="3025775"/>
                  <a:ext cx="0" cy="889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822F01EC-E063-493C-AFC3-034E35A602CD}"/>
                    </a:ext>
                  </a:extLst>
                </p:cNvPr>
                <p:cNvCxnSpPr/>
                <p:nvPr/>
              </p:nvCxnSpPr>
              <p:spPr>
                <a:xfrm>
                  <a:off x="4419658" y="3025775"/>
                  <a:ext cx="0" cy="889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>
                  <a:extLst>
                    <a:ext uri="{FF2B5EF4-FFF2-40B4-BE49-F238E27FC236}">
                      <a16:creationId xmlns:a16="http://schemas.microsoft.com/office/drawing/2014/main" id="{8456DBE1-0E56-4BB8-A566-FEE600AE8037}"/>
                    </a:ext>
                  </a:extLst>
                </p:cNvPr>
                <p:cNvCxnSpPr/>
                <p:nvPr/>
              </p:nvCxnSpPr>
              <p:spPr>
                <a:xfrm>
                  <a:off x="5820050" y="3023027"/>
                  <a:ext cx="0" cy="889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id="{3BF79E49-A048-4E53-A6A4-2DEE7A8FF21C}"/>
                    </a:ext>
                  </a:extLst>
                </p:cNvPr>
                <p:cNvCxnSpPr/>
                <p:nvPr/>
              </p:nvCxnSpPr>
              <p:spPr>
                <a:xfrm>
                  <a:off x="5981700" y="3023031"/>
                  <a:ext cx="0" cy="889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AF0CC4A-197B-4423-8CD8-C974EF8EBA1B}"/>
                  </a:ext>
                </a:extLst>
              </p:cNvPr>
              <p:cNvSpPr txBox="1"/>
              <p:nvPr/>
            </p:nvSpPr>
            <p:spPr>
              <a:xfrm>
                <a:off x="2420996" y="3417232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altLang="zh-CN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300bp</a:t>
                </a:r>
                <a:endParaRPr lang="zh-CN" altLang="en-US" sz="8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253793E-A43B-4537-A7E3-510417465461}"/>
                  </a:ext>
                </a:extLst>
              </p:cNvPr>
              <p:cNvSpPr txBox="1"/>
              <p:nvPr/>
            </p:nvSpPr>
            <p:spPr>
              <a:xfrm>
                <a:off x="4895543" y="3417232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altLang="zh-CN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400bp</a:t>
                </a:r>
                <a:endParaRPr lang="zh-CN" altLang="en-US" sz="8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427AFFEA-8B17-4180-A7E8-0318E8B868F2}"/>
                  </a:ext>
                </a:extLst>
              </p:cNvPr>
              <p:cNvSpPr txBox="1"/>
              <p:nvPr/>
            </p:nvSpPr>
            <p:spPr>
              <a:xfrm>
                <a:off x="5697909" y="3423436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altLang="zh-CN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600bp</a:t>
                </a:r>
                <a:endParaRPr lang="zh-CN" altLang="en-US" sz="8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0EFAD03-3B3B-4397-8A15-D9E64FB0FB97}"/>
                  </a:ext>
                </a:extLst>
              </p:cNvPr>
              <p:cNvSpPr txBox="1"/>
              <p:nvPr/>
            </p:nvSpPr>
            <p:spPr>
              <a:xfrm>
                <a:off x="256525" y="3317302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altLang="zh-CN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DNA quality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0FDB0A0-A468-4A5D-9C86-C44D95322759}"/>
                </a:ext>
              </a:extLst>
            </p:cNvPr>
            <p:cNvGrpSpPr/>
            <p:nvPr/>
          </p:nvGrpSpPr>
          <p:grpSpPr>
            <a:xfrm>
              <a:off x="898721" y="3625410"/>
              <a:ext cx="1900800" cy="91644"/>
              <a:chOff x="898721" y="3023031"/>
              <a:chExt cx="5082979" cy="91644"/>
            </a:xfrm>
          </p:grpSpPr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4A883699-AB7B-4646-A630-1B167AE7E6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98721" y="3070256"/>
                <a:ext cx="508297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C24E9106-EF42-4B68-BB5E-769E1CB45B65}"/>
                  </a:ext>
                </a:extLst>
              </p:cNvPr>
              <p:cNvCxnSpPr/>
              <p:nvPr/>
            </p:nvCxnSpPr>
            <p:spPr>
              <a:xfrm>
                <a:off x="901700" y="3025775"/>
                <a:ext cx="0" cy="889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CE01C7B1-DFBC-4FC3-89CB-8CD6E0AFC98C}"/>
                  </a:ext>
                </a:extLst>
              </p:cNvPr>
              <p:cNvCxnSpPr/>
              <p:nvPr/>
            </p:nvCxnSpPr>
            <p:spPr>
              <a:xfrm>
                <a:off x="5981700" y="3023031"/>
                <a:ext cx="0" cy="889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A139D37-26D0-41BA-B951-3E86930592CE}"/>
                </a:ext>
              </a:extLst>
            </p:cNvPr>
            <p:cNvSpPr txBox="1"/>
            <p:nvPr/>
          </p:nvSpPr>
          <p:spPr>
            <a:xfrm>
              <a:off x="1249995" y="3683133"/>
              <a:ext cx="11993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zh-CN" sz="800" dirty="0">
                  <a:latin typeface="Calibri" panose="020F0502020204030204" pitchFamily="34" charset="0"/>
                  <a:cs typeface="Calibri" panose="020F0502020204030204" pitchFamily="34" charset="0"/>
                </a:rPr>
                <a:t>Sequenced in duplicates</a:t>
              </a:r>
              <a:endParaRPr lang="zh-CN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03179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228</TotalTime>
  <Words>74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宋体</vt:lpstr>
      <vt:lpstr>Calibri</vt:lpstr>
      <vt:lpstr>Times New Roman</vt:lpstr>
      <vt:lpstr>Default Design</vt:lpstr>
      <vt:lpstr>PowerPoint Presentation</vt:lpstr>
    </vt:vector>
  </TitlesOfParts>
  <Company>Cambrid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g Du</dc:creator>
  <cp:lastModifiedBy>Ming Du</cp:lastModifiedBy>
  <cp:revision>574</cp:revision>
  <dcterms:created xsi:type="dcterms:W3CDTF">2009-09-20T11:37:28Z</dcterms:created>
  <dcterms:modified xsi:type="dcterms:W3CDTF">2021-05-05T13:39:26Z</dcterms:modified>
</cp:coreProperties>
</file>